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991350" cy="92773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433C76-DD7F-4B11-ACA5-0121EFDD4F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80296-F1A7-45A3-BFF3-7FF981DF82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25AF0-95F4-48E8-8840-D742818991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E263E-D5D4-4BDC-8E2E-591D8C819A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D20F2-7057-45E6-9E5F-2FDF110D0A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1649B-F6A2-4C09-9F32-8B9BC4D0F6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6BA06-CB39-4A99-8F95-F9B115D980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1A87D-E4B9-419A-84EA-2B1649490B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6DE401-7859-4200-8527-E3DE3E0B4F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B4575-1023-445A-B5C2-096544084C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568DC-0936-47F4-BC86-FF09B74224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302D6-8565-40FA-AD37-9BE22AAD5A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BCDB97-D997-43FE-8243-2F3A8F0ECB3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22240" y="2486160"/>
            <a:ext cx="7485120" cy="1797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1. Analysis of mitochondrial-encoded RNA transcript levels in A549 and A549 ρ</a:t>
            </a:r>
            <a:r>
              <a:rPr b="1" lang="en-US" sz="16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xenografts by quantitative RT-PCR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MT-ATP6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MT-CYB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ranscript levels in xenografts are normalized to levels of these same transcripts in cultured A549 cells. Transcript levels in cultured A549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ells and of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β-actin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re also shown. qPCR analysis was conducted in each of the four A549 and four A549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0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xenograft experiments and in one A549 culture and one A549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</a:t>
            </a:r>
            <a:r>
              <a:rPr b="0" lang="en-US" sz="16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culture.  Error bars represent one standard deviation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/>
          <p:nvPr/>
        </p:nvSpPr>
        <p:spPr>
          <a:xfrm>
            <a:off x="71640" y="6510240"/>
            <a:ext cx="227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gda et al. Additional Fi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038320" y="3406680"/>
            <a:ext cx="123840" cy="11098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219400" y="2871720"/>
            <a:ext cx="135000" cy="16448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411280" y="4124160"/>
            <a:ext cx="123840" cy="3924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592360" y="4076640"/>
            <a:ext cx="135000" cy="439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784600" y="3924360"/>
            <a:ext cx="123840" cy="5922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965320" y="3886200"/>
            <a:ext cx="125640" cy="630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147840" y="4181400"/>
            <a:ext cx="133560" cy="3351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338640" y="4095720"/>
            <a:ext cx="125280" cy="4208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521160" y="4105440"/>
            <a:ext cx="133200" cy="4111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711600" y="3867120"/>
            <a:ext cx="125280" cy="649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894120" y="3406680"/>
            <a:ext cx="123840" cy="11098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267080" y="2824200"/>
            <a:ext cx="123840" cy="1692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448160" y="3484440"/>
            <a:ext cx="135000" cy="10321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640400" y="3244680"/>
            <a:ext cx="123840" cy="12718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821120" y="3139920"/>
            <a:ext cx="123840" cy="1376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749920" y="3406680"/>
            <a:ext cx="123840" cy="11098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122880" y="2211480"/>
            <a:ext cx="123840" cy="23050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303960" y="3081240"/>
            <a:ext cx="133200" cy="1435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496200" y="2717640"/>
            <a:ext cx="123840" cy="1798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6676920" y="2489040"/>
            <a:ext cx="123840" cy="20275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2095560" y="3215880"/>
            <a:ext cx="1440" cy="190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066760" y="3216240"/>
            <a:ext cx="66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V="1">
            <a:off x="2286000" y="2593800"/>
            <a:ext cx="1440" cy="277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257560" y="2593800"/>
            <a:ext cx="680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V="1">
            <a:off x="2468520" y="4076640"/>
            <a:ext cx="180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440080" y="407664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V="1">
            <a:off x="2658960" y="4000320"/>
            <a:ext cx="180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630520" y="4000680"/>
            <a:ext cx="684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V="1">
            <a:off x="2841480" y="3750840"/>
            <a:ext cx="1800" cy="173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813040" y="375120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V="1">
            <a:off x="3022560" y="3876840"/>
            <a:ext cx="1800" cy="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994120" y="3876840"/>
            <a:ext cx="68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3214800" y="4152600"/>
            <a:ext cx="144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186000" y="4152960"/>
            <a:ext cx="66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V="1">
            <a:off x="3395520" y="4066920"/>
            <a:ext cx="180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367080" y="406728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3587760" y="4029120"/>
            <a:ext cx="144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559320" y="402912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3768840" y="3607920"/>
            <a:ext cx="1440" cy="258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740040" y="3608280"/>
            <a:ext cx="66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3951360" y="3292200"/>
            <a:ext cx="1440" cy="114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922560" y="3292560"/>
            <a:ext cx="66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14180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11336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4324320" y="2776680"/>
            <a:ext cx="144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295880" y="277668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4514760" y="3454200"/>
            <a:ext cx="1800" cy="29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486320" y="3454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4697280" y="3215880"/>
            <a:ext cx="180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668840" y="321624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4878360" y="3052800"/>
            <a:ext cx="1440" cy="87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849920" y="305280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07060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04180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251320" y="451656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22288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44356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41512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62464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59584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flipV="1">
            <a:off x="5807160" y="3311640"/>
            <a:ext cx="1440" cy="95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5778360" y="3311640"/>
            <a:ext cx="66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599760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96916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flipV="1">
            <a:off x="6180120" y="2173320"/>
            <a:ext cx="144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6151680" y="217332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6370560" y="3052440"/>
            <a:ext cx="180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6342120" y="305280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6553080" y="2688840"/>
            <a:ext cx="1800" cy="28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6524640" y="268920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flipV="1">
            <a:off x="6734160" y="2450880"/>
            <a:ext cx="1440" cy="37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6705720" y="245124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92640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689760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7107120" y="451656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707868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729936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727092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748044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745164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095560" y="3406680"/>
            <a:ext cx="1440" cy="182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066760" y="3589200"/>
            <a:ext cx="66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2286000" y="2871720"/>
            <a:ext cx="1440" cy="277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2257560" y="3149640"/>
            <a:ext cx="68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468520" y="4124160"/>
            <a:ext cx="1800" cy="57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440080" y="418140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658960" y="4076640"/>
            <a:ext cx="1800" cy="6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630520" y="4143240"/>
            <a:ext cx="684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841480" y="3924360"/>
            <a:ext cx="1800" cy="162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2813040" y="40863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3022560" y="388620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994120" y="3886200"/>
            <a:ext cx="68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214800" y="4181400"/>
            <a:ext cx="1440" cy="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3186000" y="4210200"/>
            <a:ext cx="66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395520" y="4095720"/>
            <a:ext cx="180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3367080" y="413388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587760" y="4105440"/>
            <a:ext cx="144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559320" y="418140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768840" y="3867120"/>
            <a:ext cx="1440" cy="257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3740040" y="4124160"/>
            <a:ext cx="66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3951360" y="3406680"/>
            <a:ext cx="1440" cy="115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3922560" y="3522600"/>
            <a:ext cx="66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414180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411336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4324320" y="2824200"/>
            <a:ext cx="144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295880" y="28623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514760" y="3484440"/>
            <a:ext cx="1800" cy="1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4486320" y="350352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4697280" y="3244680"/>
            <a:ext cx="180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4668840" y="328284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4878360" y="3139920"/>
            <a:ext cx="1440" cy="86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4849920" y="32259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507060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504180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5251320" y="451656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522288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544356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541512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562464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559584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5807160" y="3406680"/>
            <a:ext cx="1440" cy="8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5778360" y="3494160"/>
            <a:ext cx="66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599760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596916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6180120" y="2211480"/>
            <a:ext cx="144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6151680" y="224964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6370560" y="3081240"/>
            <a:ext cx="1800" cy="2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6342120" y="310212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6553080" y="2717640"/>
            <a:ext cx="1800" cy="30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6524640" y="274788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6734160" y="2489040"/>
            <a:ext cx="1440" cy="38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6705720" y="2527200"/>
            <a:ext cx="666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692640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689760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7107120" y="4516560"/>
            <a:ext cx="1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707868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729936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727092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7480440" y="4516560"/>
            <a:ext cx="14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7451640" y="4516560"/>
            <a:ext cx="666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2009880" y="1733400"/>
            <a:ext cx="1440" cy="2783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1971720" y="4516560"/>
            <a:ext cx="381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1971720" y="3962520"/>
            <a:ext cx="381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1971720" y="3406680"/>
            <a:ext cx="381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1971720" y="2843280"/>
            <a:ext cx="381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1971720" y="2287440"/>
            <a:ext cx="381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1971720" y="1733400"/>
            <a:ext cx="381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009880" y="4516560"/>
            <a:ext cx="55656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flipV="1">
            <a:off x="200988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flipV="1">
            <a:off x="219060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flipV="1">
            <a:off x="238284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flipV="1">
            <a:off x="256392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 flipV="1">
            <a:off x="275580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flipV="1">
            <a:off x="293688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 flipV="1">
            <a:off x="311940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 flipV="1">
            <a:off x="330984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 flipV="1">
            <a:off x="349236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 flipV="1">
            <a:off x="368316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 flipV="1">
            <a:off x="386568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 flipV="1">
            <a:off x="404640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flipV="1">
            <a:off x="423864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 flipV="1">
            <a:off x="441972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 flipV="1">
            <a:off x="461160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 flipV="1">
            <a:off x="479268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flipV="1">
            <a:off x="497520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flipV="1">
            <a:off x="516564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flipV="1">
            <a:off x="534816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 flipV="1">
            <a:off x="553896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flipV="1">
            <a:off x="572148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 flipV="1">
            <a:off x="590220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flipV="1">
            <a:off x="609444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 flipV="1">
            <a:off x="627552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 flipV="1">
            <a:off x="646740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 flipV="1">
            <a:off x="664848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 flipV="1">
            <a:off x="682956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 flipV="1">
            <a:off x="702144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 flipV="1">
            <a:off x="7202520" y="4516200"/>
            <a:ext cx="144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 flipV="1">
            <a:off x="739440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 flipV="1">
            <a:off x="7575480" y="4516200"/>
            <a:ext cx="1800" cy="37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1829520" y="44276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739880" y="38736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1739880" y="33177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1739880" y="27543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1739880" y="2198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1739880" y="16444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 rot="16200000">
            <a:off x="848160" y="3021840"/>
            <a:ext cx="1454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elative Expre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2679840" y="1852560"/>
            <a:ext cx="52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4470480" y="1852560"/>
            <a:ext cx="70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T- ATP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6323040" y="1852560"/>
            <a:ext cx="592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T-CY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1237320" y="5056200"/>
            <a:ext cx="654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549 viv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1071000" y="5272200"/>
            <a:ext cx="8251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549 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ρ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viv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1047600" y="4840200"/>
            <a:ext cx="8496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549 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ρ</a:t>
            </a:r>
            <a:r>
              <a:rPr b="1" lang="en-US" sz="11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vitr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1213920" y="4624560"/>
            <a:ext cx="678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549 vitr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6" name=""/>
          <p:cNvGrpSpPr/>
          <p:nvPr/>
        </p:nvGrpSpPr>
        <p:grpSpPr>
          <a:xfrm>
            <a:off x="2046240" y="4624560"/>
            <a:ext cx="1730880" cy="834480"/>
            <a:chOff x="2046240" y="4624560"/>
            <a:chExt cx="1730880" cy="834480"/>
          </a:xfrm>
        </p:grpSpPr>
        <p:sp>
          <p:nvSpPr>
            <p:cNvPr id="237" name=""/>
            <p:cNvSpPr/>
            <p:nvPr/>
          </p:nvSpPr>
          <p:spPr>
            <a:xfrm>
              <a:off x="2236680" y="484344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2046240" y="46245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242712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260820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279864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297936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314136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332244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351288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369396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7" name=""/>
          <p:cNvSpPr/>
          <p:nvPr/>
        </p:nvSpPr>
        <p:spPr>
          <a:xfrm flipH="1" flipV="1">
            <a:off x="3857760" y="1752480"/>
            <a:ext cx="9360" cy="3733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 flipH="1" flipV="1">
            <a:off x="5715000" y="1743120"/>
            <a:ext cx="9360" cy="3733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9" name=""/>
          <p:cNvGrpSpPr/>
          <p:nvPr/>
        </p:nvGrpSpPr>
        <p:grpSpPr>
          <a:xfrm>
            <a:off x="3912840" y="4624560"/>
            <a:ext cx="1730880" cy="834480"/>
            <a:chOff x="3912840" y="4624560"/>
            <a:chExt cx="1730880" cy="834480"/>
          </a:xfrm>
        </p:grpSpPr>
        <p:sp>
          <p:nvSpPr>
            <p:cNvPr id="250" name=""/>
            <p:cNvSpPr/>
            <p:nvPr/>
          </p:nvSpPr>
          <p:spPr>
            <a:xfrm>
              <a:off x="4103280" y="484344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3912840" y="46245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429372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447480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466524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484596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500796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518904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537948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556056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0" name=""/>
          <p:cNvGrpSpPr/>
          <p:nvPr/>
        </p:nvGrpSpPr>
        <p:grpSpPr>
          <a:xfrm>
            <a:off x="5779800" y="4624560"/>
            <a:ext cx="1730880" cy="834480"/>
            <a:chOff x="5779800" y="4624560"/>
            <a:chExt cx="1730880" cy="834480"/>
          </a:xfrm>
        </p:grpSpPr>
        <p:sp>
          <p:nvSpPr>
            <p:cNvPr id="261" name=""/>
            <p:cNvSpPr/>
            <p:nvPr/>
          </p:nvSpPr>
          <p:spPr>
            <a:xfrm>
              <a:off x="5970240" y="484344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5779800" y="46245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616068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634176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653220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6712920" y="508176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687492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705600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724644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7427520" y="5291280"/>
              <a:ext cx="83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02T08:10:39Z</dcterms:created>
  <dc:creator>Joseph G. Hacia</dc:creator>
  <dc:description/>
  <dc:language>en-US</dc:language>
  <cp:lastModifiedBy>Joseph G. Hacia</cp:lastModifiedBy>
  <dcterms:modified xsi:type="dcterms:W3CDTF">2008-07-17T06:42:19Z</dcterms:modified>
  <cp:revision>35</cp:revision>
  <dc:subject/>
  <dc:title>Slide 1</dc:title>
</cp:coreProperties>
</file>